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nirban Maitra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19852"/>
    <a:srgbClr val="E0A9A8"/>
    <a:srgbClr val="DB9B99"/>
    <a:srgbClr val="E1AAA9"/>
    <a:srgbClr val="E8BFBE"/>
    <a:srgbClr val="B9CB8B"/>
    <a:srgbClr val="A8BF6F"/>
    <a:srgbClr val="9EB75F"/>
    <a:srgbClr val="9EBB5F"/>
    <a:srgbClr val="D4888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9685" autoAdjust="0"/>
  </p:normalViewPr>
  <p:slideViewPr>
    <p:cSldViewPr>
      <p:cViewPr varScale="1">
        <p:scale>
          <a:sx n="107" d="100"/>
          <a:sy n="107" d="100"/>
        </p:scale>
        <p:origin x="108" y="43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998BEA-C3EA-44EF-B610-451E3499E20F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9A11A9-003D-4918-A5E6-6B5D3DD3615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02620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208785684"/>
              </p:ext>
            </p:extLst>
          </p:nvPr>
        </p:nvGraphicFramePr>
        <p:xfrm>
          <a:off x="354217" y="506041"/>
          <a:ext cx="6057900" cy="8659838"/>
        </p:xfrm>
        <a:graphic>
          <a:graphicData uri="http://schemas.openxmlformats.org/drawingml/2006/table">
            <a:tbl>
              <a:tblPr/>
              <a:tblGrid>
                <a:gridCol w="90622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3041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1993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7281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1906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2891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28053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16005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ME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ylation Status in CAFs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ME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ylation Status in CAFs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16005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036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CY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er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77398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MX1A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1598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GPT4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er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201650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RRC2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1507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HGAP26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er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2339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SP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1408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SR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er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2344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TK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47164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FR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er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2349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7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0964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RA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er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77964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PD6B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15150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FTN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er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32509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K16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5275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UBE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er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18717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ML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685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LK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er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0240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OA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1606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BCA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1683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PT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83377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CN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82830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GA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202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F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4719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MP2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116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BA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5947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T1B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18460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HGAP1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247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H9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15338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XL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15194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O1D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100133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P2B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386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CAN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38706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3GNT6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25176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INL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13448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Z1A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705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X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116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RC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5654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R2F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1719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MP7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2100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R2F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20732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0orf129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5274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XPH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100179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0orf5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2006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PN1LW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088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2249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4orf13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100446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R10H4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088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20156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GALT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100446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R10H4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31909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QTNF4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0430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FAH1B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52400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4orf3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56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RK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4468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DC4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092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E3B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298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L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2607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GFA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007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3G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91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IA4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3388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IP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78140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ZD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1297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GB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3847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X11A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185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L9A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16559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X5L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1213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PG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12268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D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3467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XCR4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33238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ML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22720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GCR8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725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U6F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746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LGAP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6258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KG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010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MD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0316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TH1R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2195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MRT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2836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TPRA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20703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DN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7069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SAL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5228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GFR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5168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ND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20704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SA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1868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NF114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1591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M135B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560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R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6329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BLN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78570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TN4RL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33086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GD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1036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YR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52536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GD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15278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SH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5197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XN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7214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C6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3322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BRG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2639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PINB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53834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R11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20737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2D4B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15234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R116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3114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AG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2491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HL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3490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YN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0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6620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BS1L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5994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BX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1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73620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DC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44659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10L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2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354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T1H4E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53354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MEM161B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3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3213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ORMAD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31466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PPC9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4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3213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ORMAD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3334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BA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5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703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F2BP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1895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BB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6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22307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CA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15017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SP3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7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057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1A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3330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PS13A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8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1557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8RB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559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BX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9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227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PO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20119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C3HAV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0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7506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AZF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22494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DHHC6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1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7506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AZF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638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NF21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2"/>
                  </a:ext>
                </a:extLst>
              </a:tr>
              <a:tr h="1113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770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B2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52655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NF585A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3"/>
                  </a:ext>
                </a:extLst>
              </a:tr>
              <a:tr h="116005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14583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MCD1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82609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NF677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4"/>
                  </a:ext>
                </a:extLst>
              </a:tr>
              <a:tr h="208810"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1004339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YG11A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meth</a:t>
                      </a: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5"/>
                  </a:ext>
                </a:extLst>
              </a:tr>
              <a:tr h="116005"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02" marR="3602" marT="3602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6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81000" y="76200"/>
            <a:ext cx="6477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 smtClean="0"/>
              <a:t>Supp</a:t>
            </a:r>
            <a:r>
              <a:rPr lang="en-US" sz="1000" b="1" dirty="0" smtClean="0"/>
              <a:t> </a:t>
            </a:r>
            <a:r>
              <a:rPr lang="en-US" sz="1000" b="1" dirty="0" smtClean="0"/>
              <a:t>File </a:t>
            </a:r>
            <a:r>
              <a:rPr lang="en-US" sz="1000" b="1" dirty="0" smtClean="0"/>
              <a:t>2: Common sets of genes epigenetically altered in primary and de novo generated CAFs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29338957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653</TotalTime>
  <Words>416</Words>
  <Application>Microsoft Office PowerPoint</Application>
  <PresentationFormat>On-screen Show (4:3)</PresentationFormat>
  <Paragraphs>39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Albert Einstein College of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ncreatic Cancer</dc:title>
  <dc:creator>Amit Verma</dc:creator>
  <cp:lastModifiedBy>Amit Verma</cp:lastModifiedBy>
  <cp:revision>461</cp:revision>
  <dcterms:created xsi:type="dcterms:W3CDTF">2012-11-01T21:56:30Z</dcterms:created>
  <dcterms:modified xsi:type="dcterms:W3CDTF">2019-10-15T18:42:20Z</dcterms:modified>
</cp:coreProperties>
</file>